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95648B-F2B8-4BB3-BDC2-80DE573BE6B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B67DFC-31B2-430F-A424-E996D5E9520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089043-4F95-4594-8E6F-37685AFF656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662C31-1CFF-45FC-B2AF-CF2B2013EBF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C752AB-C1DF-4226-A38D-DAF37219C61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0C1CD5-188E-495A-BF59-C21571BE82F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D2B2FA-F1FE-4B4B-8D1D-148BED9BE8D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C014A8-05C8-4462-B353-FF60E2DFD66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4C7EFC-1CC4-4D6C-822A-D4582487900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9F5FD1-ECA2-418C-83BB-2E078BE9A00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848DA2-6144-4CB2-9C53-640FDD0D0C3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0BCEB0-B3F4-4079-A95A-06A79C72558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4C834F9-101F-4A0F-8934-6EDA63F5C379}" type="slidenum">
              <a:rPr b="0" lang="de-DE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468360" y="1568520"/>
          <a:ext cx="8351640" cy="3022560"/>
        </p:xfrm>
        <a:graphic>
          <a:graphicData uri="http://schemas.openxmlformats.org/drawingml/2006/table">
            <a:tbl>
              <a:tblPr/>
              <a:tblGrid>
                <a:gridCol w="1090440"/>
                <a:gridCol w="669960"/>
                <a:gridCol w="1602000"/>
                <a:gridCol w="1082520"/>
                <a:gridCol w="1647720"/>
                <a:gridCol w="1130400"/>
                <a:gridCol w="1128600"/>
              </a:tblGrid>
              <a:tr h="190440">
                <a:tc rowSpan="2"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S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9edf4"/>
                    </a:solidFill>
                  </a:tcPr>
                </a:tc>
                <a:tc gridSpan="2"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univariat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9edf4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ultivariate (AIC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9edf4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ootstrap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1922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R  (95% CI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 valu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R  (95% CI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 valu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R (95% CI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374400"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iR-126                   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0</a:t>
                      </a: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(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o events in one group</a:t>
                      </a: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00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9edf4"/>
                    </a:solidFill>
                  </a:tcPr>
                </a:tc>
                <a:tc gridSpan="2"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0</a:t>
                      </a: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(</a:t>
                      </a: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o events in one group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9edf4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2 (0.08 -0.15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374760"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iR-21                   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.47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(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84  - 22.73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00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.36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(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47 - 35.38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,000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24 (2.0 -12.25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434880"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radin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.97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(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89   -   30.9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.847e-0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.61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(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61 - 28.44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00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15 (2.5 -10.85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354240"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g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99</a:t>
                      </a: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(</a:t>
                      </a: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95 - 1.03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7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372960"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76</a:t>
                      </a: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(</a:t>
                      </a: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25 - 2.48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0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353880"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ende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61</a:t>
                      </a: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(</a:t>
                      </a: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55 - 4.66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374760"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ald test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=2.15e-0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9edf4"/>
                    </a:solidFill>
                  </a:tcPr>
                </a:tc>
              </a:tr>
            </a:tbl>
          </a:graphicData>
        </a:graphic>
      </p:graphicFrame>
      <p:sp>
        <p:nvSpPr>
          <p:cNvPr id="42" name="Textfeld 1"/>
          <p:cNvSpPr/>
          <p:nvPr/>
        </p:nvSpPr>
        <p:spPr>
          <a:xfrm>
            <a:off x="79200" y="5732640"/>
            <a:ext cx="1537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</a:rPr>
              <a:t>Supp Table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11-21T15:56:03Z</dcterms:created>
  <dc:creator>Vergho_D</dc:creator>
  <dc:description/>
  <dc:language>en-US</dc:language>
  <cp:lastModifiedBy>Vergho_D</cp:lastModifiedBy>
  <dcterms:modified xsi:type="dcterms:W3CDTF">2013-11-21T15:56:24Z</dcterms:modified>
  <cp:revision>1</cp:revision>
  <dc:subject/>
  <dc:title>Folie 1</dc:title>
</cp:coreProperties>
</file>